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7" d="100"/>
          <a:sy n="57" d="100"/>
        </p:scale>
        <p:origin x="2602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29-09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129105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29-09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953879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29-09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99147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29-09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84812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29-09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02434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29-09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725269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29-09-2022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28784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29-09-2022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05552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29-09-2022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203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29-09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53141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29-09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934142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A65171-FBB8-4963-94F6-F6362E8D5168}" type="datetimeFigureOut">
              <a:rPr lang="en-IN" smtClean="0"/>
              <a:t>29-09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25442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176A8156-8829-B504-DAB7-721169B273EC}"/>
              </a:ext>
            </a:extLst>
          </p:cNvPr>
          <p:cNvGraphicFramePr>
            <a:graphicFrameLocks noGrp="1"/>
          </p:cNvGraphicFramePr>
          <p:nvPr/>
        </p:nvGraphicFramePr>
        <p:xfrm>
          <a:off x="1257300" y="609600"/>
          <a:ext cx="4572000" cy="3337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524000">
                  <a:extLst>
                    <a:ext uri="{9D8B030D-6E8A-4147-A177-3AD203B41FA5}">
                      <a16:colId xmlns:a16="http://schemas.microsoft.com/office/drawing/2014/main" val="908327112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1237869218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155356072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C enrichment sets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xis 1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xis 2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995571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</a:t>
                      </a:r>
                      <a:r>
                        <a:rPr lang="en-IN" sz="14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0749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42418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6651825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C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59923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22713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331233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</a:t>
                      </a:r>
                      <a:r>
                        <a:rPr lang="en-IN" sz="14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9799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1706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6425068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IN" sz="14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311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34528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7280009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n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165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6307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1935251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469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6895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495251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r>
                        <a:rPr lang="en-IN" sz="14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IN" sz="1400" b="1" i="0" u="none" strike="noStrike" baseline="6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40037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06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2879514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4</a:t>
                      </a:r>
                      <a:r>
                        <a:rPr lang="en-IN" sz="14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400" b="1" i="0" u="none" strike="noStrike" baseline="6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71029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182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58770472"/>
                  </a:ext>
                </a:extLst>
              </a:tr>
            </a:tbl>
          </a:graphicData>
        </a:graphic>
      </p:graphicFrame>
      <p:graphicFrame>
        <p:nvGraphicFramePr>
          <p:cNvPr id="6" name="Table 4">
            <a:extLst>
              <a:ext uri="{FF2B5EF4-FFF2-40B4-BE49-F238E27FC236}">
                <a16:creationId xmlns:a16="http://schemas.microsoft.com/office/drawing/2014/main" id="{5FBE228C-0EE4-D38A-BF63-4060910419B1}"/>
              </a:ext>
            </a:extLst>
          </p:cNvPr>
          <p:cNvGraphicFramePr>
            <a:graphicFrameLocks noGrp="1"/>
          </p:cNvGraphicFramePr>
          <p:nvPr/>
        </p:nvGraphicFramePr>
        <p:xfrm>
          <a:off x="1257300" y="5102860"/>
          <a:ext cx="4572000" cy="3337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524000">
                  <a:extLst>
                    <a:ext uri="{9D8B030D-6E8A-4147-A177-3AD203B41FA5}">
                      <a16:colId xmlns:a16="http://schemas.microsoft.com/office/drawing/2014/main" val="908327112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1237869218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155356072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 enrichment sets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xis 1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xis 2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995571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</a:t>
                      </a:r>
                      <a:r>
                        <a:rPr lang="en-IN" sz="14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8789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7251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6651825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C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50188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30401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331233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</a:t>
                      </a:r>
                      <a:r>
                        <a:rPr lang="en-IN" sz="14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6382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6604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6425068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IN" sz="14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274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7561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7280009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n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02462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6358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1935251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30095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1098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495251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r>
                        <a:rPr lang="en-IN" sz="14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IN" sz="1400" b="1" i="0" u="none" strike="noStrike" baseline="6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6454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2776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2879514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4</a:t>
                      </a:r>
                      <a:r>
                        <a:rPr lang="en-IN" sz="14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400" b="1" i="0" u="none" strike="noStrike" baseline="6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51837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4734</a:t>
                      </a: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58770472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62B5DF39-A0E5-0884-7C68-286088696929}"/>
              </a:ext>
            </a:extLst>
          </p:cNvPr>
          <p:cNvSpPr txBox="1"/>
          <p:nvPr/>
        </p:nvSpPr>
        <p:spPr>
          <a:xfrm>
            <a:off x="633046" y="86380"/>
            <a:ext cx="5970954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4(A): Relationships between the selected main geochemical parameters and the first two CCA axes in HC enrichments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6ECB7F0-648B-0E10-93EF-2957545EC3CA}"/>
              </a:ext>
            </a:extLst>
          </p:cNvPr>
          <p:cNvSpPr txBox="1"/>
          <p:nvPr/>
        </p:nvSpPr>
        <p:spPr>
          <a:xfrm>
            <a:off x="557823" y="4470380"/>
            <a:ext cx="5970954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table 4(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: Relationships between the selected main geochemical parameters and the first two CCA axes in BC enrichments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9806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20</Words>
  <Application>Microsoft Office PowerPoint</Application>
  <PresentationFormat>A4 Paper (210x297 mm)</PresentationFormat>
  <Paragraphs>5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NANDA MANDAL</dc:creator>
  <cp:lastModifiedBy>SUNANDA MANDAL</cp:lastModifiedBy>
  <cp:revision>4</cp:revision>
  <dcterms:created xsi:type="dcterms:W3CDTF">2022-08-11T19:48:06Z</dcterms:created>
  <dcterms:modified xsi:type="dcterms:W3CDTF">2022-09-29T16:31:47Z</dcterms:modified>
</cp:coreProperties>
</file>